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7" r:id="rId1"/>
    <p:sldMasterId id="2147483684" r:id="rId2"/>
  </p:sldMasterIdLst>
  <p:notesMasterIdLst>
    <p:notesMasterId r:id="rId8"/>
  </p:notesMasterIdLst>
  <p:sldIdLst>
    <p:sldId id="295" r:id="rId3"/>
    <p:sldId id="296" r:id="rId4"/>
    <p:sldId id="265" r:id="rId5"/>
    <p:sldId id="280" r:id="rId6"/>
    <p:sldId id="294" r:id="rId7"/>
  </p:sldIdLst>
  <p:sldSz cx="6858000" cy="9144000" type="letter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56EFA160-8D6B-1E53-652A-928B6D0CCBAC}" name="Alison Obergrussberger" initials="AO" userId="S::Ali.Obergrussberger@nanion.de::5fb842b2-726e-4e15-b7f3-ae139a0d559f" providerId="AD"/>
  <p188:author id="{0517926E-0C11-230D-8387-3843FFF4ABAB}" name="Vincent Truong" initials="VT" userId="Vincent Truong" providerId="None"/>
  <p188:author id="{F32AAC76-1185-63C0-585C-25CF73D3543C}" name="Tim Strassmaier" initials="TS" userId="S::Tim.Strassmaier@nanion.de::a5fd6f3c-aa91-4b87-8b2d-1a1e77b88b44" providerId="AD"/>
  <p188:author id="{07513F81-6866-8703-ABC9-BFF8163614F2}" name="Vincent Truong" initials="VT" userId="S::Vince@AnatomicIncorporated.onmicrosoft.com::3d269529-dd8c-4736-a1b9-6f245ab26bf9" providerId="AD"/>
  <p188:author id="{69D6ABDA-1264-822A-C345-384DAB52DE5B}" name="Marc ROGERS" initials="MR" userId="2375f71568d85132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ACD"/>
    <a:srgbClr val="FFB400"/>
    <a:srgbClr val="7BBA3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29" autoAdjust="0"/>
    <p:restoredTop sz="95789" autoAdjust="0"/>
  </p:normalViewPr>
  <p:slideViewPr>
    <p:cSldViewPr snapToGrid="0">
      <p:cViewPr varScale="1">
        <p:scale>
          <a:sx n="85" d="100"/>
          <a:sy n="85" d="100"/>
        </p:scale>
        <p:origin x="63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8/10/relationships/authors" Target="authors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theme" Target="theme/theme1.xml"/><Relationship Id="rId5" Type="http://schemas.openxmlformats.org/officeDocument/2006/relationships/slide" Target="slides/slide3.xml"/><Relationship Id="rId10" Type="http://schemas.openxmlformats.org/officeDocument/2006/relationships/viewProps" Target="viewProps.xml"/><Relationship Id="rId4" Type="http://schemas.openxmlformats.org/officeDocument/2006/relationships/slide" Target="slides/slide2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746740C-F4DF-4E03-84F8-8AE8905BEC95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703638" y="857250"/>
            <a:ext cx="173672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7BEA41C-ACAD-4A28-A9C5-34EA502AE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46756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E7098DA-9F10-477E-9BEA-7E7C332D4594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07016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CFB71D-6386-2365-36D3-EF0B066B9C1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497013"/>
            <a:ext cx="5143500" cy="318293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D49F0BC-9484-0D11-E071-27DD25DE94D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4802188"/>
            <a:ext cx="5143500" cy="220821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ABDCFA-1C53-ABB4-6F06-5CFFD15D56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660E3C-05F8-4AB5-B54A-AA30D00EC6DF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E40A9C-DE2F-8795-C031-3635E913B1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69A726-7D4B-28CD-40E3-E3CC104256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F8759-71B0-4BBC-B879-898F49A4B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82781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E042D1-779E-45C0-D51A-1E3EE4B049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2F0DCD3-1CA6-FFF4-E057-5268EF6C75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33D105-51D2-9BD6-E710-4B7BB1E4FD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660E3C-05F8-4AB5-B54A-AA30D00EC6DF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C81E25-2A07-8A1C-DE8A-D5FBDD568D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FBB9A2-6EED-22BE-956E-9EEEB3C48C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F8759-71B0-4BBC-B879-898F49A4B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73266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10BCAEC-CEC8-634C-08A2-16AC3613741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8550" y="487363"/>
            <a:ext cx="1477963" cy="774858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2AB397E-C61C-B4FD-3849-9CEA2A4D6A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8" y="487363"/>
            <a:ext cx="4284662" cy="774858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1E8F46-A8F4-8EFC-1B3C-993F462860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660E3C-05F8-4AB5-B54A-AA30D00EC6DF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7B26A4-4CBB-E84C-038D-AFB5CD81C1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F71BEE-D2AD-7439-4D67-946DB02E90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F8759-71B0-4BBC-B879-898F49A4B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697065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969769325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418A79-460A-8920-96A6-28C29CCE9F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487363"/>
            <a:ext cx="5915025" cy="1766887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B147F2-96E7-1C13-6EE0-7217B90ADC7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71488" y="2433638"/>
            <a:ext cx="5915025" cy="5802312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C61374-CF3E-3193-07B2-C91DBE14108F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471488" y="8475663"/>
            <a:ext cx="1543050" cy="485775"/>
          </a:xfrm>
          <a:prstGeom prst="rect">
            <a:avLst/>
          </a:prstGeom>
        </p:spPr>
        <p:txBody>
          <a:bodyPr/>
          <a:lstStyle/>
          <a:p>
            <a:fld id="{2E3A79DD-E3C8-4FC4-AEF3-028DC8DCF13B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2D9D3D-B206-4BC6-127E-649CEC1113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2271713" y="8475663"/>
            <a:ext cx="2314575" cy="48577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8D4D20-A5F7-A90E-A159-E67F917903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4843463" y="8475663"/>
            <a:ext cx="1543050" cy="485775"/>
          </a:xfrm>
          <a:prstGeom prst="rect">
            <a:avLst/>
          </a:prstGeom>
        </p:spPr>
        <p:txBody>
          <a:bodyPr/>
          <a:lstStyle/>
          <a:p>
            <a:fld id="{38229273-83B3-4730-BD4D-733C874AC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502256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676B21-0984-6B97-5238-BD9176F8A4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8313" y="2279650"/>
            <a:ext cx="5915025" cy="3803650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3673D5-8189-EF5B-7D6C-E09BD89C1D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8313" y="6119813"/>
            <a:ext cx="5915025" cy="200025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AD31FA-2D3B-DCDA-5CFA-62B8A5997B8C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471488" y="8475663"/>
            <a:ext cx="1543050" cy="485775"/>
          </a:xfrm>
          <a:prstGeom prst="rect">
            <a:avLst/>
          </a:prstGeom>
        </p:spPr>
        <p:txBody>
          <a:bodyPr/>
          <a:lstStyle/>
          <a:p>
            <a:fld id="{2E3A79DD-E3C8-4FC4-AEF3-028DC8DCF13B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A5CE1D-F50D-1CEB-B1B1-24B060DF4A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2271713" y="8475663"/>
            <a:ext cx="2314575" cy="48577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12C34C-4315-6501-6555-C54EAAB5D6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4843463" y="8475663"/>
            <a:ext cx="1543050" cy="485775"/>
          </a:xfrm>
          <a:prstGeom prst="rect">
            <a:avLst/>
          </a:prstGeom>
        </p:spPr>
        <p:txBody>
          <a:bodyPr/>
          <a:lstStyle/>
          <a:p>
            <a:fld id="{38229273-83B3-4730-BD4D-733C874AC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7450539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4F4A65-F22A-B4AD-894C-A1A169285C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487363"/>
            <a:ext cx="5915025" cy="1766887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36B2F1-DBAB-54E2-1902-606F3EB5101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433638"/>
            <a:ext cx="2881312" cy="5802312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DBE89D2-629D-3AD0-EEAE-1491F6E72C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505200" y="2433638"/>
            <a:ext cx="2881313" cy="5802312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A06663-CA0C-8819-5BC1-43BC334CDF4E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471488" y="8475663"/>
            <a:ext cx="1543050" cy="485775"/>
          </a:xfrm>
          <a:prstGeom prst="rect">
            <a:avLst/>
          </a:prstGeom>
        </p:spPr>
        <p:txBody>
          <a:bodyPr/>
          <a:lstStyle/>
          <a:p>
            <a:fld id="{2E3A79DD-E3C8-4FC4-AEF3-028DC8DCF13B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F7FE170-5C6F-FE60-B0FB-26536F67C0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2271713" y="8475663"/>
            <a:ext cx="2314575" cy="48577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BC6228-8536-ACB3-CC6F-71E9C3E835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4843463" y="8475663"/>
            <a:ext cx="1543050" cy="485775"/>
          </a:xfrm>
          <a:prstGeom prst="rect">
            <a:avLst/>
          </a:prstGeom>
        </p:spPr>
        <p:txBody>
          <a:bodyPr/>
          <a:lstStyle/>
          <a:p>
            <a:fld id="{38229273-83B3-4730-BD4D-733C874AC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25698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A72962-08FA-FE21-5AE0-D480B9F8AA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3075" y="487363"/>
            <a:ext cx="5915025" cy="1766887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37C8DDA-FB4E-252E-D2A9-33EEC7F7C4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3075" y="2241550"/>
            <a:ext cx="2900363" cy="1098550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45A6658-E4DC-4448-660C-09138713165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3075" y="3340100"/>
            <a:ext cx="2900363" cy="4913313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D2B0D58-9FAA-124D-6906-03DDB56288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241550"/>
            <a:ext cx="2916237" cy="1098550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72D83DC-0745-9822-253E-922999D1C25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6237" cy="4913313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351C8DC-6A78-6111-67B5-17745C1257F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471488" y="8475663"/>
            <a:ext cx="1543050" cy="485775"/>
          </a:xfrm>
          <a:prstGeom prst="rect">
            <a:avLst/>
          </a:prstGeom>
        </p:spPr>
        <p:txBody>
          <a:bodyPr/>
          <a:lstStyle/>
          <a:p>
            <a:fld id="{2E3A79DD-E3C8-4FC4-AEF3-028DC8DCF13B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42F94FD-5564-70B5-39AF-89DA9A9B51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2271713" y="8475663"/>
            <a:ext cx="2314575" cy="48577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850E478-E442-B80D-7AF5-D84561757F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4843463" y="8475663"/>
            <a:ext cx="1543050" cy="485775"/>
          </a:xfrm>
          <a:prstGeom prst="rect">
            <a:avLst/>
          </a:prstGeom>
        </p:spPr>
        <p:txBody>
          <a:bodyPr/>
          <a:lstStyle/>
          <a:p>
            <a:fld id="{38229273-83B3-4730-BD4D-733C874AC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152693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941FE2-360C-922A-82EA-949E6AA093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487363"/>
            <a:ext cx="5915025" cy="1766887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68B16FD-B531-5C79-35DA-3DB9D7F889C6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471488" y="8475663"/>
            <a:ext cx="1543050" cy="485775"/>
          </a:xfrm>
          <a:prstGeom prst="rect">
            <a:avLst/>
          </a:prstGeom>
        </p:spPr>
        <p:txBody>
          <a:bodyPr/>
          <a:lstStyle/>
          <a:p>
            <a:fld id="{2E3A79DD-E3C8-4FC4-AEF3-028DC8DCF13B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2143A7A-D7AF-134D-3309-5ED3119B56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2271713" y="8475663"/>
            <a:ext cx="2314575" cy="48577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69B5780-8C9C-B04A-4208-BC0D1B3BA2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4843463" y="8475663"/>
            <a:ext cx="1543050" cy="485775"/>
          </a:xfrm>
          <a:prstGeom prst="rect">
            <a:avLst/>
          </a:prstGeom>
        </p:spPr>
        <p:txBody>
          <a:bodyPr/>
          <a:lstStyle/>
          <a:p>
            <a:fld id="{38229273-83B3-4730-BD4D-733C874AC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3319876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FF73566-D2FD-0712-9B38-8C6E9138F905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471488" y="8475663"/>
            <a:ext cx="1543050" cy="485775"/>
          </a:xfrm>
          <a:prstGeom prst="rect">
            <a:avLst/>
          </a:prstGeom>
        </p:spPr>
        <p:txBody>
          <a:bodyPr/>
          <a:lstStyle/>
          <a:p>
            <a:fld id="{2E3A79DD-E3C8-4FC4-AEF3-028DC8DCF13B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9BF1509-E810-046A-9192-AE53BB34CF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2271713" y="8475663"/>
            <a:ext cx="2314575" cy="48577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14A3528-2857-1BED-3F24-94703FBD92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4843463" y="8475663"/>
            <a:ext cx="1543050" cy="485775"/>
          </a:xfrm>
          <a:prstGeom prst="rect">
            <a:avLst/>
          </a:prstGeom>
        </p:spPr>
        <p:txBody>
          <a:bodyPr/>
          <a:lstStyle/>
          <a:p>
            <a:fld id="{38229273-83B3-4730-BD4D-733C874AC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2037514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C8FCA1-ADD3-A6D0-C50B-C788FF5BA4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3075" y="609600"/>
            <a:ext cx="2211388" cy="21336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0925196-BB35-AE1E-E070-92B94765EE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6238" y="1316038"/>
            <a:ext cx="3471862" cy="6499225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9EB61C5-3F35-321E-47D4-27E8C4A6C4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3075" y="2743200"/>
            <a:ext cx="2211388" cy="508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DBAE8D-C21D-C419-500E-7E9F0FD2D94D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471488" y="8475663"/>
            <a:ext cx="1543050" cy="485775"/>
          </a:xfrm>
          <a:prstGeom prst="rect">
            <a:avLst/>
          </a:prstGeom>
        </p:spPr>
        <p:txBody>
          <a:bodyPr/>
          <a:lstStyle/>
          <a:p>
            <a:fld id="{2E3A79DD-E3C8-4FC4-AEF3-028DC8DCF13B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087AED2-4AC4-D095-D48E-E22E503B47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2271713" y="8475663"/>
            <a:ext cx="2314575" cy="48577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44F2FA2-D493-1A79-5355-16C87EC874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4843463" y="8475663"/>
            <a:ext cx="1543050" cy="485775"/>
          </a:xfrm>
          <a:prstGeom prst="rect">
            <a:avLst/>
          </a:prstGeom>
        </p:spPr>
        <p:txBody>
          <a:bodyPr/>
          <a:lstStyle/>
          <a:p>
            <a:fld id="{38229273-83B3-4730-BD4D-733C874AC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63694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50965F-E4FB-310D-310D-D55E1CFAC0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99FDE4-4867-8735-6CCB-DC1FE03D82E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72A993-8B16-E6BC-0C46-EBDB4E7783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660E3C-05F8-4AB5-B54A-AA30D00EC6DF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0BAC91-0DA1-D91E-19F9-782CCC444B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F37005-CBD7-517F-C788-CD59ED6C98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F8759-71B0-4BBC-B879-898F49A4B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9325347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CFFF95-3845-AB8F-2F6C-55EEB17789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3075" y="609600"/>
            <a:ext cx="2211388" cy="21336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A7259C9-F46F-5F2B-63F5-B572DA39A88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6238" y="1316038"/>
            <a:ext cx="3471862" cy="6499225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258936-BA8B-E16A-98F4-A9791D384D3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3075" y="2743200"/>
            <a:ext cx="2211388" cy="508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D167C52-F644-2832-C212-2B4445427C0B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471488" y="8475663"/>
            <a:ext cx="1543050" cy="485775"/>
          </a:xfrm>
          <a:prstGeom prst="rect">
            <a:avLst/>
          </a:prstGeom>
        </p:spPr>
        <p:txBody>
          <a:bodyPr/>
          <a:lstStyle/>
          <a:p>
            <a:fld id="{2E3A79DD-E3C8-4FC4-AEF3-028DC8DCF13B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91EA960-0908-433B-3D05-A5A61F608E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2271713" y="8475663"/>
            <a:ext cx="2314575" cy="48577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4EC3AFA-071A-43E9-C46D-743F2E8DA2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4843463" y="8475663"/>
            <a:ext cx="1543050" cy="485775"/>
          </a:xfrm>
          <a:prstGeom prst="rect">
            <a:avLst/>
          </a:prstGeom>
        </p:spPr>
        <p:txBody>
          <a:bodyPr/>
          <a:lstStyle/>
          <a:p>
            <a:fld id="{38229273-83B3-4730-BD4D-733C874AC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2230613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958E93-A877-43FF-E9EA-1291726810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487363"/>
            <a:ext cx="5915025" cy="1766887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A45DB5F-3008-2537-9BF4-C3553DEBCF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8" y="2433638"/>
            <a:ext cx="5915025" cy="5802312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F21969-71D1-B9F5-63B1-0FA5C69F4B72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471488" y="8475663"/>
            <a:ext cx="1543050" cy="485775"/>
          </a:xfrm>
          <a:prstGeom prst="rect">
            <a:avLst/>
          </a:prstGeom>
        </p:spPr>
        <p:txBody>
          <a:bodyPr/>
          <a:lstStyle/>
          <a:p>
            <a:fld id="{2E3A79DD-E3C8-4FC4-AEF3-028DC8DCF13B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D98ECC-F908-7745-C639-6D1148CDDC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2271713" y="8475663"/>
            <a:ext cx="2314575" cy="48577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70C211-8AFD-3B3B-8158-8FB3FFAF06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4843463" y="8475663"/>
            <a:ext cx="1543050" cy="485775"/>
          </a:xfrm>
          <a:prstGeom prst="rect">
            <a:avLst/>
          </a:prstGeom>
        </p:spPr>
        <p:txBody>
          <a:bodyPr/>
          <a:lstStyle/>
          <a:p>
            <a:fld id="{38229273-83B3-4730-BD4D-733C874AC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7803459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615DE9B-F510-F78D-1280-6F77009580C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8550" y="487363"/>
            <a:ext cx="1477963" cy="7748587"/>
          </a:xfrm>
          <a:prstGeom prst="rect">
            <a:avLst/>
          </a:prstGeo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EA279CF-B6EC-BC04-BD2F-A8D693D9F8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8" y="487363"/>
            <a:ext cx="4284662" cy="7748587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7CF265-0775-07C5-01BB-D5F77B6E249D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471488" y="8475663"/>
            <a:ext cx="1543050" cy="485775"/>
          </a:xfrm>
          <a:prstGeom prst="rect">
            <a:avLst/>
          </a:prstGeom>
        </p:spPr>
        <p:txBody>
          <a:bodyPr/>
          <a:lstStyle/>
          <a:p>
            <a:fld id="{2E3A79DD-E3C8-4FC4-AEF3-028DC8DCF13B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D6AADC-FFC9-57BB-E601-6E85EBBF5D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2271713" y="8475663"/>
            <a:ext cx="2314575" cy="48577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35C8F1-C2EF-62CA-6DAD-04D99CC897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4843463" y="8475663"/>
            <a:ext cx="1543050" cy="485775"/>
          </a:xfrm>
          <a:prstGeom prst="rect">
            <a:avLst/>
          </a:prstGeom>
        </p:spPr>
        <p:txBody>
          <a:bodyPr/>
          <a:lstStyle/>
          <a:p>
            <a:fld id="{38229273-83B3-4730-BD4D-733C874AC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98585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7BB4B1-EFD8-33A3-9DAB-33A9C5E963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487363"/>
            <a:ext cx="5915025" cy="1766887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14363619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7E2C6B-F13B-7604-970A-788F1633C2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8313" y="2279650"/>
            <a:ext cx="5915025" cy="3803650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A699AE-7087-F482-BF80-BFCC640C13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8313" y="6119813"/>
            <a:ext cx="5915025" cy="2000250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C06197-251A-3611-E0D1-E231862F71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660E3C-05F8-4AB5-B54A-AA30D00EC6DF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6617AC-B49F-AAED-8260-395D6D18BA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870134-7359-0E0D-B7F3-6F6C42EC13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F8759-71B0-4BBC-B879-898F49A4B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27382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715C77-1A9C-B615-B5CA-6565121DD4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088CD5D-0155-EA04-1737-7BEDB89A1A6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433638"/>
            <a:ext cx="2881312" cy="58023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5CAE981-D092-D2E2-F875-0D4D26B8606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505200" y="2433638"/>
            <a:ext cx="2881313" cy="58023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EE8AAEE-0BDC-6050-3E2E-C5EDCAAD35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660E3C-05F8-4AB5-B54A-AA30D00EC6DF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5979B40-9A6A-D64D-ACB9-DC3631D357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E0A462E-DDC6-54A2-6CE8-19A300B0B1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F8759-71B0-4BBC-B879-898F49A4B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37388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1FB13E-0C31-B0C1-F5FB-20CBB698A4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3075" y="487363"/>
            <a:ext cx="5915025" cy="176688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1D6B28A-D06B-1437-AA22-506307B386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3075" y="2241550"/>
            <a:ext cx="2900363" cy="109855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ADDE318-1C22-8451-A447-BEF9456519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3075" y="3340100"/>
            <a:ext cx="2900363" cy="491331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1FD3763-D5A7-C0A5-99B2-E7A77136B97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241550"/>
            <a:ext cx="2916237" cy="109855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CF3072A-07B3-77DD-5517-EFCBBA2D396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6237" cy="491331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69A7785-F7BC-2DA7-F667-2775472310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660E3C-05F8-4AB5-B54A-AA30D00EC6DF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45BB59E-0826-45F5-DAFE-29D430AA0A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188E253-10B4-12C6-F0D4-2FE3643E17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F8759-71B0-4BBC-B879-898F49A4B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68309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E9AE15-7A7A-194A-8EB7-5E58E3B278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7A1F1A5-3351-E1B3-2866-5043B0259A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660E3C-05F8-4AB5-B54A-AA30D00EC6DF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4E5F884-1B84-D7B5-499B-B50765A962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CBBC9C5-7AF3-8C58-30FC-D2BCD90F7F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F8759-71B0-4BBC-B879-898F49A4B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98877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12E8CE7-8E0F-E4B5-60E0-31CAD1D56E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660E3C-05F8-4AB5-B54A-AA30D00EC6DF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01214B5-56C1-7271-7E3A-64FC0FF1F8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9058E30-1A0B-45D6-A8C8-23CA5835BD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F8759-71B0-4BBC-B879-898F49A4B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81159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FDC773-90BA-E998-AE83-AEA80AED12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3075" y="609600"/>
            <a:ext cx="2211388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2F080A-C315-A27E-1E9B-AE03FEF82CB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6238" y="1316038"/>
            <a:ext cx="3471862" cy="64992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5467461-D5D5-0CA2-5745-4A599CD5A7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3075" y="2743200"/>
            <a:ext cx="2211388" cy="508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5159C3-72D2-0791-BF51-7C38E9CE25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660E3C-05F8-4AB5-B54A-AA30D00EC6DF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8DAF19-7778-CC6D-AB4D-99E3858334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C7C6C1F-11F5-07FC-4DF1-EDB0C60490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F8759-71B0-4BBC-B879-898F49A4B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7941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417DAD-6421-E7DA-D143-C0AE3523AF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3075" y="609600"/>
            <a:ext cx="2211388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2C6FAE1-C9CA-E2BE-34B3-6C79EAC8494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6238" y="1316038"/>
            <a:ext cx="3471862" cy="64992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69E68A8-6328-5B83-EBD6-1AF367C235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3075" y="2743200"/>
            <a:ext cx="2211388" cy="508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7E4F2E9-BBE5-DDF6-3BB6-B04023F1A7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660E3C-05F8-4AB5-B54A-AA30D00EC6DF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04BD72-E899-1243-459A-15B6DC6AF7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51B48DC-F8DB-C2D9-E83D-5D1DE49D20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F8759-71B0-4BBC-B879-898F49A4B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0827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slideLayout" Target="../slideLayouts/slideLayout23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DFBE711-8A60-62A1-B9DC-2762CBCCE5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487363"/>
            <a:ext cx="5915025" cy="176688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55D6B9-FB8B-971B-62A3-3F6703F352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433638"/>
            <a:ext cx="5915025" cy="58023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F50451-C864-E8D9-BBE8-A680482DBD6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8475663"/>
            <a:ext cx="154305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E660E3C-05F8-4AB5-B54A-AA30D00EC6DF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6A25F7-3B54-08DE-655B-2D08C4F7019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8475663"/>
            <a:ext cx="2314575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FA6D73-2199-D158-F133-A4C91F4B412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8475663"/>
            <a:ext cx="154305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41F8759-71B0-4BBC-B879-898F49A4B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07317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8" r:id="rId1"/>
    <p:sldLayoutId id="2147483699" r:id="rId2"/>
    <p:sldLayoutId id="2147483700" r:id="rId3"/>
    <p:sldLayoutId id="2147483701" r:id="rId4"/>
    <p:sldLayoutId id="2147483702" r:id="rId5"/>
    <p:sldLayoutId id="2147483703" r:id="rId6"/>
    <p:sldLayoutId id="2147483704" r:id="rId7"/>
    <p:sldLayoutId id="2147483705" r:id="rId8"/>
    <p:sldLayoutId id="2147483706" r:id="rId9"/>
    <p:sldLayoutId id="2147483707" r:id="rId10"/>
    <p:sldLayoutId id="2147483708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6543740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  <p:sldLayoutId id="2147483696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8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8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8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8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857A7C57-1A77-4401-96D5-956C19A09D2D}"/>
              </a:ext>
            </a:extLst>
          </p:cNvPr>
          <p:cNvGraphicFramePr>
            <a:graphicFrameLocks noGrp="1"/>
          </p:cNvGraphicFramePr>
          <p:nvPr/>
        </p:nvGraphicFramePr>
        <p:xfrm>
          <a:off x="457200" y="372599"/>
          <a:ext cx="5943600" cy="839880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990600">
                  <a:extLst>
                    <a:ext uri="{9D8B030D-6E8A-4147-A177-3AD203B41FA5}">
                      <a16:colId xmlns:a16="http://schemas.microsoft.com/office/drawing/2014/main" val="2507279600"/>
                    </a:ext>
                  </a:extLst>
                </a:gridCol>
                <a:gridCol w="990600">
                  <a:extLst>
                    <a:ext uri="{9D8B030D-6E8A-4147-A177-3AD203B41FA5}">
                      <a16:colId xmlns:a16="http://schemas.microsoft.com/office/drawing/2014/main" val="2233348834"/>
                    </a:ext>
                  </a:extLst>
                </a:gridCol>
                <a:gridCol w="990600">
                  <a:extLst>
                    <a:ext uri="{9D8B030D-6E8A-4147-A177-3AD203B41FA5}">
                      <a16:colId xmlns:a16="http://schemas.microsoft.com/office/drawing/2014/main" val="1732637157"/>
                    </a:ext>
                  </a:extLst>
                </a:gridCol>
                <a:gridCol w="990600">
                  <a:extLst>
                    <a:ext uri="{9D8B030D-6E8A-4147-A177-3AD203B41FA5}">
                      <a16:colId xmlns:a16="http://schemas.microsoft.com/office/drawing/2014/main" val="1233020328"/>
                    </a:ext>
                  </a:extLst>
                </a:gridCol>
                <a:gridCol w="990600">
                  <a:extLst>
                    <a:ext uri="{9D8B030D-6E8A-4147-A177-3AD203B41FA5}">
                      <a16:colId xmlns:a16="http://schemas.microsoft.com/office/drawing/2014/main" val="2242537911"/>
                    </a:ext>
                  </a:extLst>
                </a:gridCol>
                <a:gridCol w="990600">
                  <a:extLst>
                    <a:ext uri="{9D8B030D-6E8A-4147-A177-3AD203B41FA5}">
                      <a16:colId xmlns:a16="http://schemas.microsoft.com/office/drawing/2014/main" val="1556311546"/>
                    </a:ext>
                  </a:extLst>
                </a:gridCol>
              </a:tblGrid>
              <a:tr h="20081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blication</a:t>
                      </a:r>
                      <a:endParaRPr lang="en-US" sz="7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erall strategy</a:t>
                      </a:r>
                      <a:endParaRPr lang="en-US" sz="70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arly patterning / induction</a:t>
                      </a:r>
                      <a:endParaRPr lang="en-US" sz="70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plating / maturation</a:t>
                      </a:r>
                      <a:endParaRPr lang="en-US" sz="7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prox. timeline to usable neurons</a:t>
                      </a:r>
                      <a:endParaRPr lang="en-US" sz="70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in output emphasized</a:t>
                      </a:r>
                      <a:endParaRPr lang="en-US" sz="70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53953443"/>
                  </a:ext>
                </a:extLst>
              </a:tr>
              <a:tr h="165923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ckolls et al., 2020 (Cell Reports, PMID 31968264)</a:t>
                      </a:r>
                      <a:endParaRPr lang="en-US" sz="7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nscription factor programming of engineered iPSCs with doxycycline-inducible NGN2 + BRN3A; notably no small-molecule neural induction in the base </a:t>
                      </a:r>
                      <a:r>
                        <a:rPr lang="en-US" sz="700" dirty="0" err="1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SN</a:t>
                      </a: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rotocol.</a:t>
                      </a:r>
                      <a:endParaRPr lang="en-US" sz="7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0: plate iPSCs in NDM + Y-27632 + doxycycline; day 2: replate onto PEI/laminin; day 8: add BDNF, GDNF, NGF, NT-3; doxycycline maintained through day 14. They also describe neural crest-derived variants (NC-iSN1 and NC-iSN2) that add neural crest staging and, for NC-iSN2, early retinoic acid + neurotrophins.</a:t>
                      </a:r>
                      <a:endParaRPr lang="en-US" sz="7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ture morphology by ~day 14; most characterization performed day 21+.</a:t>
                      </a:r>
                      <a:endParaRPr lang="en-US" sz="7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~21 days for the main </a:t>
                      </a:r>
                      <a:r>
                        <a:rPr lang="en-US" sz="700" dirty="0" err="1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SN</a:t>
                      </a: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workflow.</a:t>
                      </a:r>
                      <a:endParaRPr lang="en-US" sz="7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arily mechanosensory / cold-mechanosensory-like sensory neurons, with subtype tuning possible via neural crest staging.</a:t>
                      </a:r>
                      <a:endParaRPr lang="en-US" sz="7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1081236"/>
                  </a:ext>
                </a:extLst>
              </a:tr>
              <a:tr h="155505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ark et al., 2021 (Cell Reports Medicine, PMID 34337561)</a:t>
                      </a:r>
                      <a:endParaRPr lang="en-US" sz="70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ified stepwise small-molecule sensory neuron differentiation applied to patient and control iPSCs for HSN1 disease modeling.</a:t>
                      </a:r>
                      <a:endParaRPr lang="en-US" sz="7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rt with dual SMAD inhibition: SB431542 + LDN-193189 in KSR medium. On day 3 add CHIR99021 + SU5402 + DAPT. Dual SMAD inhibitors are withdrawn on day 5, while medium is gradually shifted toward N2/B27.</a:t>
                      </a:r>
                      <a:endParaRPr lang="en-US" sz="7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12: replate onto coverslips in N2/B27 plus BDNF, NT3, NGF, GDNF at 25 ng/mL; CHIR is continued 4 more days. </a:t>
                      </a:r>
                      <a:r>
                        <a:rPr lang="en-US" sz="700" dirty="0" err="1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aC</a:t>
                      </a: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an be used after replating to eliminate residual dividing non-neuronal cells. From day 28 onward, trophic factors are reduced to 10 ng/mL and phenol-free Matrigel is added during feeds.</a:t>
                      </a:r>
                      <a:endParaRPr lang="en-US" sz="7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nsory neuron identity is assessed at 4 weeks after differentiation; longer maturation is also used in the study.</a:t>
                      </a:r>
                      <a:endParaRPr lang="en-US" sz="7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oad iPSC-derived sensory neurons for neuropathy modeling rather than a narrowly defined nociceptor subtype protocol.</a:t>
                      </a:r>
                      <a:endParaRPr lang="en-US" sz="7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50045574"/>
                  </a:ext>
                </a:extLst>
              </a:tr>
              <a:tr h="155505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 dirty="0" err="1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umbly</a:t>
                      </a: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t al., 2022 (Cell Reports Methods, PMID 36452863)</a:t>
                      </a:r>
                      <a:endParaRPr lang="en-US" sz="7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brid protocol: standard small-molecule sensory induction plus temporally controlled inducible NEUROG2 overexpression after early patterning.</a:t>
                      </a:r>
                      <a:endParaRPr lang="en-US" sz="7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te iPSCs, then day 0 switch to KSR with LDN-193189 + SB431542. On day 3 add DAPT + SU5402 + CHIR99021 while keeping the dual SMAD inhibitors. From day 4 onward, gradually transition KSR to N2B27; remove the dual SMAD inhibitors on day 7. (PMC)</a:t>
                      </a:r>
                      <a:endParaRPr lang="en-US" sz="70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11: dissociate and replate in N2B27 with BDNF, GDNF, NT-3, NGF plus doxycycline to induce NEUROG2. Cultures are then maintained in this maturation medium, typically to day 35-40. The paper contrasts this with a “standard” protocol using mitomycin C on day 14 instead of NEUROG2 induction.</a:t>
                      </a:r>
                      <a:endParaRPr lang="en-US" sz="7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~35-40 days for mature nociceptive sensory neurons.</a:t>
                      </a:r>
                      <a:endParaRPr lang="en-US" sz="7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ciceptive sensory neurons, with the NEUROG2 hybrid approach intended to improve reproducibility and maturation versus the standard small-molecule method.</a:t>
                      </a:r>
                      <a:endParaRPr lang="en-US" sz="7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44750627"/>
                  </a:ext>
                </a:extLst>
              </a:tr>
              <a:tr h="124717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ng et al., 2023 (Stem Cell Reports, PMID 37044067)</a:t>
                      </a:r>
                      <a:endParaRPr lang="en-US" sz="7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epwise small-molecule differentiation designed for scalable nociceptor production, including robotic culture.</a:t>
                      </a:r>
                      <a:endParaRPr lang="en-US" sz="7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 dirty="0" err="1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PSCs</a:t>
                      </a: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lated at high density, then treated with A83-01 (TGF-β inhibitor) + CHIR98014 (WNT activation). On day 3, cells are moved into </a:t>
                      </a:r>
                      <a:r>
                        <a:rPr lang="en-US" sz="700" dirty="0" err="1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greWell</a:t>
                      </a: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ormat to form “</a:t>
                      </a:r>
                      <a:r>
                        <a:rPr lang="en-US" sz="700" dirty="0" err="1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cispheres</a:t>
                      </a: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” then cultured through day 14 with CHIR98014 + A83-01 + DBZ + PD173074 to drive a SOX10+ neural crest-like intermediate.</a:t>
                      </a:r>
                      <a:endParaRPr lang="en-US" sz="7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14: dissociate </a:t>
                      </a:r>
                      <a:r>
                        <a:rPr lang="en-US" sz="700" dirty="0" err="1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cispheres</a:t>
                      </a: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nd plate for maturation with PD0332991 plus neurotrophic factors; cultures can be cryopreserved at day 14 or matured further. Day-28 neurons were used extensively for morphology, transcriptomics, calcium imaging, MEA, ELISA, and patch-clamp workflows.</a:t>
                      </a:r>
                      <a:endParaRPr lang="en-US" sz="7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~28 days for experimental nociceptors; day 14 is a major transition / bank point.</a:t>
                      </a:r>
                      <a:endParaRPr lang="en-US" sz="7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xed </a:t>
                      </a:r>
                      <a:r>
                        <a:rPr lang="en-US" sz="700" dirty="0" err="1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ptidergic</a:t>
                      </a: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nd non-</a:t>
                      </a:r>
                      <a:r>
                        <a:rPr lang="en-US" sz="700" dirty="0" err="1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ptidergic</a:t>
                      </a: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ociceptors, optimized for scale and screening.</a:t>
                      </a:r>
                      <a:endParaRPr lang="en-US" sz="7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6409828"/>
                  </a:ext>
                </a:extLst>
              </a:tr>
              <a:tr h="124717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his study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atomic </a:t>
                      </a:r>
                      <a:r>
                        <a:rPr lang="en-US" sz="700" dirty="0" err="1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iSNs</a:t>
                      </a:r>
                      <a:endParaRPr lang="en-US" sz="7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tepwise small-molecule differentiation designed for scalable nociceptor production (Senso-DM)</a:t>
                      </a: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roprietary formulation based on Primal Ectoderm [11]</a:t>
                      </a: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haw and culture in Senso-MM</a:t>
                      </a: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-35 days</a:t>
                      </a: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7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ix of mechanoreceptors and nociceptors</a:t>
                      </a:r>
                    </a:p>
                  </a:txBody>
                  <a:tcPr marL="20132" marR="2013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1587202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664220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8A7D256-54F8-85E5-5054-D20AD1F79511}"/>
              </a:ext>
            </a:extLst>
          </p:cNvPr>
          <p:cNvSpPr txBox="1"/>
          <p:nvPr/>
        </p:nvSpPr>
        <p:spPr>
          <a:xfrm>
            <a:off x="457200" y="388570"/>
            <a:ext cx="5943600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1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omparison of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iPSC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derived sensory neuron differentiation protocols across studies. Overview of differentiation strategies from selected publications, including induction approach (e.g., transcription factor programming versus small-molecule patterning), key signaling modulators, replating and maturation conditions, and approximate timelines to functional neuronal readouts. Protocols are presented at a high level to highlight major methodological differences and are not intended to capture all experimental variations within each study.</a:t>
            </a:r>
          </a:p>
        </p:txBody>
      </p:sp>
    </p:spTree>
    <p:extLst>
      <p:ext uri="{BB962C8B-B14F-4D97-AF65-F5344CB8AC3E}">
        <p14:creationId xmlns:p14="http://schemas.microsoft.com/office/powerpoint/2010/main" val="37777482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06E6784-9CDD-AB0E-814E-3D9410E6FDBE}"/>
              </a:ext>
            </a:extLst>
          </p:cNvPr>
          <p:cNvSpPr txBox="1"/>
          <p:nvPr/>
        </p:nvSpPr>
        <p:spPr>
          <a:xfrm>
            <a:off x="524313" y="7843470"/>
            <a:ext cx="594360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Voltage gated sodium channel expression across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iPSC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derived sensory neuron populations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with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DRG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without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DRG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TRP channel expression across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iPSC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derived sensory neuron populations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with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DRG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without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DRG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Voltage gated calcium channel expression across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iPSC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derived sensory neuron populations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E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with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DRG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without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DRG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</p:txBody>
      </p:sp>
      <p:pic>
        <p:nvPicPr>
          <p:cNvPr id="3" name="Picture 2" descr="A diagram of different types of cell division&#10;&#10;AI-generated content may be incorrect.">
            <a:extLst>
              <a:ext uri="{FF2B5EF4-FFF2-40B4-BE49-F238E27FC236}">
                <a16:creationId xmlns:a16="http://schemas.microsoft.com/office/drawing/2014/main" id="{4F5CDCAC-4CB9-CA52-1ECF-78D88A82FBC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4313" y="324295"/>
            <a:ext cx="6004560" cy="72486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178473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395B6F64-7508-BFF2-5E16-A6F547C20F26}"/>
              </a:ext>
            </a:extLst>
          </p:cNvPr>
          <p:cNvSpPr txBox="1"/>
          <p:nvPr/>
        </p:nvSpPr>
        <p:spPr>
          <a:xfrm>
            <a:off x="559848" y="8395660"/>
            <a:ext cx="59436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Heatmap analysis in only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iPSC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derived sensory neurons for specific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Ion Channels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Neuropeptides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GPCRs and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Cell adhesion molecules.</a:t>
            </a:r>
          </a:p>
        </p:txBody>
      </p:sp>
      <p:pic>
        <p:nvPicPr>
          <p:cNvPr id="4" name="Picture 3" descr="A close-up of a graph&#10;&#10;AI-generated content may be incorrect.">
            <a:extLst>
              <a:ext uri="{FF2B5EF4-FFF2-40B4-BE49-F238E27FC236}">
                <a16:creationId xmlns:a16="http://schemas.microsoft.com/office/drawing/2014/main" id="{F34D0D37-7B16-8A5D-6B88-20723D9AC82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2796" y="317453"/>
            <a:ext cx="5752407" cy="80273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006492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CB481CD-0B8E-C971-7AC5-C92ECD871684}"/>
              </a:ext>
            </a:extLst>
          </p:cNvPr>
          <p:cNvSpPr txBox="1"/>
          <p:nvPr/>
        </p:nvSpPr>
        <p:spPr>
          <a:xfrm>
            <a:off x="457200" y="3985471"/>
            <a:ext cx="5943600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 Elicited action potentials in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hiSNs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are abolished by TTX. A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ction potentials were elicited using the protocol shown in Figure 9B in vehicle (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and in the presence of 500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TTX (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. TTX completely abolished action potentials in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iSN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Data recorded on the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SyncroPatch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384.</a:t>
            </a:r>
          </a:p>
        </p:txBody>
      </p:sp>
      <p:pic>
        <p:nvPicPr>
          <p:cNvPr id="5" name="Picture 4" descr="A black background with white text&#10;&#10;AI-generated content may be incorrect.">
            <a:extLst>
              <a:ext uri="{FF2B5EF4-FFF2-40B4-BE49-F238E27FC236}">
                <a16:creationId xmlns:a16="http://schemas.microsoft.com/office/drawing/2014/main" id="{EBFB2139-F3EB-3BE8-0365-683F468F72F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274" y="543049"/>
            <a:ext cx="5852172" cy="30388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90932621"/>
      </p:ext>
    </p:extLst>
  </p:cSld>
  <p:clrMapOvr>
    <a:masterClrMapping/>
  </p:clrMapOvr>
</p:sld>
</file>

<file path=ppt/theme/theme1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604</TotalTime>
  <Words>930</Words>
  <Application>Microsoft Office PowerPoint</Application>
  <PresentationFormat>Letter Paper (8.5x11 in)</PresentationFormat>
  <Paragraphs>42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ptos</vt:lpstr>
      <vt:lpstr>Aptos Display</vt:lpstr>
      <vt:lpstr>Arial</vt:lpstr>
      <vt:lpstr>Calibri</vt:lpstr>
      <vt:lpstr>1_Custom Design</vt:lpstr>
      <vt:lpstr>Custom Desig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ncent Truong</dc:creator>
  <cp:lastModifiedBy>Alison Obergrussberger</cp:lastModifiedBy>
  <cp:revision>86</cp:revision>
  <dcterms:created xsi:type="dcterms:W3CDTF">2023-01-11T16:16:11Z</dcterms:created>
  <dcterms:modified xsi:type="dcterms:W3CDTF">2026-03-31T16:11:18Z</dcterms:modified>
</cp:coreProperties>
</file>